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chu\Documents\CIHI%20HCV%20data\HCV_hospitalizations_updated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Yearly rate of HCV-specific</a:t>
            </a:r>
            <a:r>
              <a:rPr lang="en-US" baseline="0"/>
              <a:t> hospitalizations with HCC per 1,000,000 of Canadian population, by age group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6"/>
          <c:order val="0"/>
          <c:tx>
            <c:strRef>
              <c:f>Age!$R$1</c:f>
              <c:strCache>
                <c:ptCount val="1"/>
                <c:pt idx="0">
                  <c:v>Under 30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Age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Age!$R$2:$R$15</c:f>
              <c:numCache>
                <c:formatCode>General</c:formatCode>
                <c:ptCount val="1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9D4-4FB8-87D8-7CC7013F75B9}"/>
            </c:ext>
          </c:extLst>
        </c:ser>
        <c:ser>
          <c:idx val="17"/>
          <c:order val="1"/>
          <c:tx>
            <c:strRef>
              <c:f>Age!$S$1</c:f>
              <c:strCache>
                <c:ptCount val="1"/>
                <c:pt idx="0">
                  <c:v>30 to 49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cat>
            <c:numRef>
              <c:f>Age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Age!$S$2:$S$15</c:f>
              <c:numCache>
                <c:formatCode>General</c:formatCode>
                <c:ptCount val="14"/>
                <c:pt idx="0">
                  <c:v>5.5655747144000038</c:v>
                </c:pt>
                <c:pt idx="1">
                  <c:v>0</c:v>
                </c:pt>
                <c:pt idx="2">
                  <c:v>6.3195417149890769</c:v>
                </c:pt>
                <c:pt idx="3">
                  <c:v>7.0525912753517659</c:v>
                </c:pt>
                <c:pt idx="4">
                  <c:v>5.9494666662153284</c:v>
                </c:pt>
                <c:pt idx="5">
                  <c:v>5.9766445098028305</c:v>
                </c:pt>
                <c:pt idx="6">
                  <c:v>4.3301986818875218</c:v>
                </c:pt>
                <c:pt idx="7">
                  <c:v>4.2349334495702058</c:v>
                </c:pt>
                <c:pt idx="8">
                  <c:v>2.6906390184880014</c:v>
                </c:pt>
                <c:pt idx="9">
                  <c:v>3.9470398655181196</c:v>
                </c:pt>
                <c:pt idx="10">
                  <c:v>2.9983516303433597</c:v>
                </c:pt>
                <c:pt idx="11">
                  <c:v>1.4369534124307761</c:v>
                </c:pt>
                <c:pt idx="12">
                  <c:v>1.318487836442598</c:v>
                </c:pt>
                <c:pt idx="13">
                  <c:v>1.19919569944438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9D4-4FB8-87D8-7CC7013F75B9}"/>
            </c:ext>
          </c:extLst>
        </c:ser>
        <c:ser>
          <c:idx val="18"/>
          <c:order val="2"/>
          <c:tx>
            <c:strRef>
              <c:f>Age!$T$1</c:f>
              <c:strCache>
                <c:ptCount val="1"/>
                <c:pt idx="0">
                  <c:v>50 to 64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Age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Age!$T$2:$T$15</c:f>
              <c:numCache>
                <c:formatCode>General</c:formatCode>
                <c:ptCount val="14"/>
                <c:pt idx="0">
                  <c:v>46.427517754409628</c:v>
                </c:pt>
                <c:pt idx="1">
                  <c:v>54.246921487205597</c:v>
                </c:pt>
                <c:pt idx="2">
                  <c:v>51.922831886658464</c:v>
                </c:pt>
                <c:pt idx="3">
                  <c:v>73.968166492032054</c:v>
                </c:pt>
                <c:pt idx="4">
                  <c:v>70.272572093501068</c:v>
                </c:pt>
                <c:pt idx="5">
                  <c:v>74.994209798557378</c:v>
                </c:pt>
                <c:pt idx="6">
                  <c:v>79.826920847388365</c:v>
                </c:pt>
                <c:pt idx="7">
                  <c:v>95.397400637644893</c:v>
                </c:pt>
                <c:pt idx="8">
                  <c:v>85.054920227787704</c:v>
                </c:pt>
                <c:pt idx="9">
                  <c:v>87.158754174230339</c:v>
                </c:pt>
                <c:pt idx="10">
                  <c:v>75.451405535229199</c:v>
                </c:pt>
                <c:pt idx="11">
                  <c:v>57.422081461416489</c:v>
                </c:pt>
                <c:pt idx="12">
                  <c:v>58.205238883572008</c:v>
                </c:pt>
                <c:pt idx="13">
                  <c:v>43.2388692726836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9D4-4FB8-87D8-7CC7013F75B9}"/>
            </c:ext>
          </c:extLst>
        </c:ser>
        <c:ser>
          <c:idx val="19"/>
          <c:order val="3"/>
          <c:tx>
            <c:strRef>
              <c:f>Age!$U$1</c:f>
              <c:strCache>
                <c:ptCount val="1"/>
                <c:pt idx="0">
                  <c:v>65+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Age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Age!$U$2:$U$15</c:f>
              <c:numCache>
                <c:formatCode>General</c:formatCode>
                <c:ptCount val="14"/>
                <c:pt idx="0">
                  <c:v>38.667199517655625</c:v>
                </c:pt>
                <c:pt idx="1">
                  <c:v>34.604588296999644</c:v>
                </c:pt>
                <c:pt idx="2">
                  <c:v>37.8761520295892</c:v>
                </c:pt>
                <c:pt idx="3">
                  <c:v>38.763632859139165</c:v>
                </c:pt>
                <c:pt idx="4">
                  <c:v>50.582689687688323</c:v>
                </c:pt>
                <c:pt idx="5">
                  <c:v>51.662534672926718</c:v>
                </c:pt>
                <c:pt idx="6">
                  <c:v>43.453489344292663</c:v>
                </c:pt>
                <c:pt idx="7">
                  <c:v>51.186413257804105</c:v>
                </c:pt>
                <c:pt idx="8">
                  <c:v>48.355149083615792</c:v>
                </c:pt>
                <c:pt idx="9">
                  <c:v>47.184344164703418</c:v>
                </c:pt>
                <c:pt idx="10">
                  <c:v>56.240803868556632</c:v>
                </c:pt>
                <c:pt idx="11">
                  <c:v>41.238713143511376</c:v>
                </c:pt>
                <c:pt idx="12">
                  <c:v>41.381142031408132</c:v>
                </c:pt>
                <c:pt idx="13">
                  <c:v>37.8787304867719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9D4-4FB8-87D8-7CC7013F75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83477103"/>
        <c:axId val="283475439"/>
      </c:lineChart>
      <c:catAx>
        <c:axId val="28347710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3475439"/>
        <c:crosses val="autoZero"/>
        <c:auto val="1"/>
        <c:lblAlgn val="ctr"/>
        <c:lblOffset val="100"/>
        <c:noMultiLvlLbl val="0"/>
      </c:catAx>
      <c:valAx>
        <c:axId val="2834754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ate per 1,000,00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347710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2789DC-A1C5-C807-127D-9617964269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85496C-33B9-2D2D-272A-11BDF97D1B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C01100-EC2F-FE1E-50AA-56EB86811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10508D-82E4-4C06-8166-59BF2F515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CAAD4E-236D-7C11-569C-89E0A0A7D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88145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174FE8-0CBB-2FB4-7AE8-98BAD81C71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D82EAE-42C8-5B6B-0CAA-7C422894B4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AAD8A1-C381-CE11-40C8-C9637249F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228B4B-AA1C-4A17-79F7-633DBD619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F23F34-1CE6-87AA-8F8A-AF348A307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46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CEFEDC2-6118-A065-C700-A9B5B8AAC9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0EEF6B-F84E-0090-864C-C9EBEED79E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C3C7A4-8B95-E3D1-06A5-374C22506A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74F9EA-C111-C45F-B71F-89B5B353C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E5FA7-1215-0E1B-0C5D-FA768D80B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7251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9170A-492C-C516-790D-37350BEACF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78E867-EA96-FC9A-4EF1-C3368E09DC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D2B7DC-7A9A-F176-BFC0-AE35160C5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163EFC-A846-B18F-9863-0497CDF1F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149B6B-0627-5FF4-8591-1BBB7F957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281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D8F159-E67B-4B27-CF7D-D9E7944A24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AAC859-01AF-0917-FC38-BDC9BA8FCA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B399F1-8B8E-4297-ABEA-BCA05A85A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7E34E1-C420-BC44-AE60-E66E598BE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D1E1A8-3515-D57D-9E3E-4FCFF37554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3139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B64DAC-E365-9559-2BEB-0194834AE9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D9AB26-4B9F-6141-07F5-A8A8FE5730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888D4B-147D-8B60-4FC5-45AEEAFB68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554052-4C2B-6604-DB6F-20B93B9E8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BB4D1C-8506-2B3D-6203-9BBC293A6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8A222A-D209-4D27-90F0-4F734BFE7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9515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BE0F09-7CB3-DCB2-7BF5-E412E5E5DA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9BAEBD-AF95-F7D2-87E5-236AFC3335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FB32CD-60D0-A1C3-24D3-9BF6761482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9FE4EF-3E04-1881-DF90-C6CF6664EE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F8BC9D8-5E6B-1155-4F02-BA75BD0812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2C1F98-3F36-893D-D032-BAF0B5162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3A9A03-795C-8250-9499-179FC7D79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63727E-24A4-DF9F-BAEA-12A46AC0F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92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72FFE9-49C2-BBD7-FC3F-39462EFE81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464C95C-C5B8-0302-17C5-A66AC6B6D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42DDE5-6AF6-5C19-200D-1B0AA0859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1B7E24-D767-5A9D-8A35-0249F17AF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88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A00D66-4795-116D-6C3F-C16066AAF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711C5D-0B6C-14E4-2FC5-780416F25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60EDE2-DD8F-B48D-920F-68646BB5B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096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D3C5A4-FAEA-9805-84FD-A0A50D8035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8D533C-1908-1366-3961-6781A7D179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35A483-269C-AE36-8287-CE7E8DEFF4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F9D09A-5202-4021-DAD2-256F1EF90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E7A435-23AD-E36D-69A2-687FAF20C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F1D1FB-3A69-259B-4C16-5D4ABE1D7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897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488FF5-0619-04EE-B707-0C125CDD71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79EF1CF-470B-7D2D-9298-2B6086F08D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E5FE3-94D2-DFF8-6826-43D11C49B7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E832E8-29AD-D231-BBB0-209CE76A5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6CC3D7-DE67-0554-4FE0-51729F2EA2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671BE9-7191-A5D2-83A9-C39DF6B67B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579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3ABBC1-4998-8B1B-2B05-09CB4F0E9B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E180A4-36C5-D672-1664-04C6346A6F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1FEE28-7ABD-C3C5-ED7B-C565F0C2C4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FCAA4-C0F7-4B08-832A-F223A30B6FF6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4C1544-EE78-9E0C-8538-5971394F8E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ED653F-B446-8D53-0CAB-941327CBAD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8ED25-8DA0-4D8B-A42F-212887B44E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269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F9497686-9A7D-4ADB-9E3E-B767ADFB1019}"/>
              </a:ext>
            </a:extLst>
          </p:cNvPr>
          <p:cNvGraphicFramePr>
            <a:graphicFrameLocks/>
          </p:cNvGraphicFramePr>
          <p:nvPr/>
        </p:nvGraphicFramePr>
        <p:xfrm>
          <a:off x="1226515" y="1166105"/>
          <a:ext cx="9231419" cy="46292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3DFA574-529A-442B-BC5D-8BB701F0DEE8}"/>
              </a:ext>
            </a:extLst>
          </p:cNvPr>
          <p:cNvCxnSpPr>
            <a:cxnSpLocks/>
          </p:cNvCxnSpPr>
          <p:nvPr/>
        </p:nvCxnSpPr>
        <p:spPr>
          <a:xfrm>
            <a:off x="6967152" y="1849394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C3DFA574-529A-442B-BC5D-8BB701F0DEE8}"/>
              </a:ext>
            </a:extLst>
          </p:cNvPr>
          <p:cNvCxnSpPr>
            <a:cxnSpLocks/>
          </p:cNvCxnSpPr>
          <p:nvPr/>
        </p:nvCxnSpPr>
        <p:spPr>
          <a:xfrm>
            <a:off x="8763000" y="1849394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CD17711C-C0C7-A212-2051-5B82F8263DD1}"/>
              </a:ext>
            </a:extLst>
          </p:cNvPr>
          <p:cNvSpPr txBox="1"/>
          <p:nvPr/>
        </p:nvSpPr>
        <p:spPr>
          <a:xfrm>
            <a:off x="354227" y="350108"/>
            <a:ext cx="1989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2 Figure</a:t>
            </a:r>
          </a:p>
        </p:txBody>
      </p:sp>
    </p:spTree>
    <p:extLst>
      <p:ext uri="{BB962C8B-B14F-4D97-AF65-F5344CB8AC3E}">
        <p14:creationId xmlns:p14="http://schemas.microsoft.com/office/powerpoint/2010/main" val="1562561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omen's College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, Cherry</dc:creator>
  <cp:lastModifiedBy>Chu, Cherry</cp:lastModifiedBy>
  <cp:revision>1</cp:revision>
  <dcterms:created xsi:type="dcterms:W3CDTF">2023-07-26T15:46:05Z</dcterms:created>
  <dcterms:modified xsi:type="dcterms:W3CDTF">2023-07-26T15:46:28Z</dcterms:modified>
</cp:coreProperties>
</file>